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1" r:id="rId2"/>
    <p:sldId id="287" r:id="rId3"/>
    <p:sldId id="259" r:id="rId4"/>
    <p:sldId id="285" r:id="rId5"/>
    <p:sldId id="286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aurai tasara" initials="tt" lastIdx="1" clrIdx="0">
    <p:extLst>
      <p:ext uri="{19B8F6BF-5375-455C-9EA6-DF929625EA0E}">
        <p15:presenceInfo xmlns:p15="http://schemas.microsoft.com/office/powerpoint/2012/main" userId="94c40e37b218cb0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AC963E9-2BBC-4EC9-A333-AB190F3DA4F4}" v="25" dt="2020-06-02T08:43:46.50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216" autoAdjust="0"/>
    <p:restoredTop sz="94660"/>
  </p:normalViewPr>
  <p:slideViewPr>
    <p:cSldViewPr snapToGrid="0">
      <p:cViewPr varScale="1">
        <p:scale>
          <a:sx n="96" d="100"/>
          <a:sy n="96" d="100"/>
        </p:scale>
        <p:origin x="84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8B026A-B076-41A8-864C-C90CA848BA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53200B1-1289-4469-9EE7-09562353ABD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974F04-C27D-4AC2-9EA5-B5F9AF509C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B9BD7-E9E2-4D72-A164-FB3F2070B7F8}" type="datetimeFigureOut">
              <a:rPr lang="en-GB" smtClean="0"/>
              <a:t>15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9872EB-C59B-464E-B907-CDD2149F8F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71D305-E471-4232-9E7E-1378672183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85BCF-D3F6-43C1-BD3C-40541A2628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01113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4637B4-760A-4DC6-B8E1-20CFDE3E7A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6A6732-6879-4E42-81E8-974401A943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D474CA-341E-4A35-96EE-4995F15471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B9BD7-E9E2-4D72-A164-FB3F2070B7F8}" type="datetimeFigureOut">
              <a:rPr lang="en-GB" smtClean="0"/>
              <a:t>15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DFBA21-602A-4CE2-872C-CA3BA24B11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137CCE-0857-4B90-A79B-A1209DC93A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85BCF-D3F6-43C1-BD3C-40541A2628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9230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DE3A787-268F-44E8-84F9-6B7C6D0F4E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1F6044-D6C0-4C91-8B13-6930005D86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DE48A2-44F3-41DF-9104-F59773A341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B9BD7-E9E2-4D72-A164-FB3F2070B7F8}" type="datetimeFigureOut">
              <a:rPr lang="en-GB" smtClean="0"/>
              <a:t>15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418470-0DB2-4734-89B2-4FEA0DFCAE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CB4ED2-068C-4E2B-B61D-540B36B468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85BCF-D3F6-43C1-BD3C-40541A2628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0048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B2FE87-DEDE-4CAE-AEEA-B099F53093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576580-7605-4C39-A2AD-23D5D5DD89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049A1B-0B2E-413B-B7F5-8B0AA28EBC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B9BD7-E9E2-4D72-A164-FB3F2070B7F8}" type="datetimeFigureOut">
              <a:rPr lang="en-GB" smtClean="0"/>
              <a:t>15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BA3E74-795B-4473-982A-72A38B2F1C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8CFA7C-7875-44EA-AFEC-197E467DF7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85BCF-D3F6-43C1-BD3C-40541A2628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65662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BE3FBA-AFDA-42E7-9149-B4323CB230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9F9AAF-D0D7-4A88-9924-BFAEDD14B7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223B67-A04A-4183-83EC-EC18D5B9EA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B9BD7-E9E2-4D72-A164-FB3F2070B7F8}" type="datetimeFigureOut">
              <a:rPr lang="en-GB" smtClean="0"/>
              <a:t>15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CF55A9-A085-4FC2-913D-3845DB1601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362246-97F0-4AFB-B3CD-9AEB9ECB7B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85BCF-D3F6-43C1-BD3C-40541A2628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15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D7B173-B98B-43D5-BDEB-A59AEA9B00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999455-96F8-45A9-A6E6-C0B572F66D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BC3E04E-6AE7-4D30-AE8C-C547CB66AA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36DF1F-7900-48B5-A7A8-3BCF9D631F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B9BD7-E9E2-4D72-A164-FB3F2070B7F8}" type="datetimeFigureOut">
              <a:rPr lang="en-GB" smtClean="0"/>
              <a:t>15/1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6950B5-4215-4671-A799-AAE57A88C2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42CBD7-34FB-4BF9-AF3E-92085B2D4C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85BCF-D3F6-43C1-BD3C-40541A2628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41667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54258C-F77C-434C-8FD7-CA054F1588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ADF85C-F397-45ED-939F-3E170CAE81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4DBA25-039F-4E90-B367-0EB3534300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101E191-993C-4938-A398-865883EF0A2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6E0ACBC-03CD-45FE-8B10-0FADEF5352E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9420256-F361-4961-A84E-B3E909D618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B9BD7-E9E2-4D72-A164-FB3F2070B7F8}" type="datetimeFigureOut">
              <a:rPr lang="en-GB" smtClean="0"/>
              <a:t>15/12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98C1D82-FF9F-4421-AB63-43E30553D3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D5DFD40-0AFD-4C8E-BB67-AD73BBE92B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85BCF-D3F6-43C1-BD3C-40541A2628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5707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C3A3BD-3FEF-4E0D-AA5E-C40391BA6C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7F9B8D5-D769-47AF-9DFB-CD9E0BFB73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B9BD7-E9E2-4D72-A164-FB3F2070B7F8}" type="datetimeFigureOut">
              <a:rPr lang="en-GB" smtClean="0"/>
              <a:t>15/12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16EFE9A-31A7-4DD1-83ED-F393B9D88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EB1B3E-0AB8-4058-AFF4-AB90BE384E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85BCF-D3F6-43C1-BD3C-40541A2628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55577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B542AF2-DCE9-420D-9D2A-3D70C3CBB0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B9BD7-E9E2-4D72-A164-FB3F2070B7F8}" type="datetimeFigureOut">
              <a:rPr lang="en-GB" smtClean="0"/>
              <a:t>15/12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4831B72-B5AD-4581-A3D5-D1904B14DC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ACCDD1D-92B0-41BE-BFD5-D8A2E9E83E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85BCF-D3F6-43C1-BD3C-40541A2628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9472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DA55A2-CD11-4498-BDB1-E34069D1D2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B34E2C-FA5B-4958-B0C7-2A13DC1000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A116B7-83FF-4D8E-9AAF-527EF0EBF4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3D80E2-7699-4D05-9AC0-DA96F094F1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B9BD7-E9E2-4D72-A164-FB3F2070B7F8}" type="datetimeFigureOut">
              <a:rPr lang="en-GB" smtClean="0"/>
              <a:t>15/1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5BE27C-473D-4C23-8A64-66CFD328B3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810522-5E5F-4341-83C9-87B2070123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85BCF-D3F6-43C1-BD3C-40541A2628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390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D2CEB6-CCB5-4C47-A711-0D1C17D982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5D91E58-22AE-45F4-A3EE-71F2866F59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716F36-E045-476C-A371-C0E2BF7933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CC4908-2ECB-4AE2-8F70-B036E1BC25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B9BD7-E9E2-4D72-A164-FB3F2070B7F8}" type="datetimeFigureOut">
              <a:rPr lang="en-GB" smtClean="0"/>
              <a:t>15/1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498498-A2F8-46EA-BECE-D387935C08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D48E6A-D5CF-4033-9832-1E871EC785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85BCF-D3F6-43C1-BD3C-40541A2628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7645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44E5B83-22F2-4687-BC55-976C0705C8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AE2BA6-CA4C-49E3-9EE5-CA9FF774A8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7DEFF2-B60D-439E-89BB-0EDC84B9F1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FB9BD7-E9E2-4D72-A164-FB3F2070B7F8}" type="datetimeFigureOut">
              <a:rPr lang="en-GB" smtClean="0"/>
              <a:t>15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70FCEE-C377-45BE-A436-03BACF5AE4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626D26-C64E-414E-897D-7E8BD66B4D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685BCF-D3F6-43C1-BD3C-40541A2628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89845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671218B2-C375-4E20-AC50-2E7A31BA3C87}"/>
              </a:ext>
            </a:extLst>
          </p:cNvPr>
          <p:cNvSpPr txBox="1"/>
          <p:nvPr/>
        </p:nvSpPr>
        <p:spPr>
          <a:xfrm>
            <a:off x="527976" y="667328"/>
            <a:ext cx="357266" cy="381823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GB" b="1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533FBFB-81A1-424E-9680-98FCFC85DD67}"/>
              </a:ext>
            </a:extLst>
          </p:cNvPr>
          <p:cNvSpPr txBox="1"/>
          <p:nvPr/>
        </p:nvSpPr>
        <p:spPr>
          <a:xfrm>
            <a:off x="5171287" y="1577943"/>
            <a:ext cx="5065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WT</a:t>
            </a:r>
            <a:endParaRPr lang="en-CH" sz="14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78E074C-C143-4AC2-B353-C06AE79A476E}"/>
              </a:ext>
            </a:extLst>
          </p:cNvPr>
          <p:cNvSpPr txBox="1"/>
          <p:nvPr/>
        </p:nvSpPr>
        <p:spPr>
          <a:xfrm>
            <a:off x="10165404" y="2245479"/>
            <a:ext cx="5065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WT</a:t>
            </a:r>
            <a:endParaRPr lang="en-CH" sz="14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0A0ED42-EC3F-4A40-9D0E-0C563508D3FE}"/>
              </a:ext>
            </a:extLst>
          </p:cNvPr>
          <p:cNvSpPr txBox="1"/>
          <p:nvPr/>
        </p:nvSpPr>
        <p:spPr>
          <a:xfrm>
            <a:off x="5508919" y="667328"/>
            <a:ext cx="357266" cy="381823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GB" b="1" dirty="0">
                <a:latin typeface="Palatino Linotype" panose="02040502050505030304" pitchFamily="18" charset="0"/>
              </a:rPr>
              <a:t>B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137030AC-1B49-4BA0-B826-B6149B9D0D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0640" y="702624"/>
            <a:ext cx="4882250" cy="36000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12C520D9-BD06-4862-A4C7-5F40776F67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60434" y="702624"/>
            <a:ext cx="4882250" cy="36000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B19856A-2741-4260-B99B-F5E197810E4F}"/>
              </a:ext>
            </a:extLst>
          </p:cNvPr>
          <p:cNvSpPr txBox="1"/>
          <p:nvPr/>
        </p:nvSpPr>
        <p:spPr>
          <a:xfrm>
            <a:off x="210614" y="5263461"/>
            <a:ext cx="11521652" cy="83099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Nisin stress growth efficiency comparison between EGDe WT and the single (∆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∆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∆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double (∆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B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∆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A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∆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A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triple (∆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AB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letion mutants. Growth </a:t>
            </a:r>
            <a:r>
              <a:rPr lang="en-GB" sz="12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parameters LPD (A) and MD (B) under nisin stress normalized to normal BHI growth parameters determined for the </a:t>
            </a:r>
            <a:r>
              <a:rPr lang="en-GB" sz="1200" i="1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csp</a:t>
            </a:r>
            <a:r>
              <a:rPr lang="en-GB" sz="12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 mutant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expressed relative to the WT strain levels (WT strain levels equivalent to 1.0 are denoted by a broken line in the graph).</a:t>
            </a:r>
            <a:r>
              <a:rPr lang="en-GB" sz="12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 Results presented are based on three independent experiments that were performed in duplicates. * </a:t>
            </a:r>
            <a:r>
              <a:rPr lang="en-GB" sz="1200" i="1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P</a:t>
            </a:r>
            <a:r>
              <a:rPr lang="en-GB" sz="12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&lt;0.05 significant differences compared to the WT detected using Tukey post-hoc test pairwise comparison following one-way ANOVA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C289D59-984C-7C4D-8771-89A5C77C5790}"/>
              </a:ext>
            </a:extLst>
          </p:cNvPr>
          <p:cNvSpPr txBox="1"/>
          <p:nvPr/>
        </p:nvSpPr>
        <p:spPr>
          <a:xfrm>
            <a:off x="8736029" y="718316"/>
            <a:ext cx="338554" cy="47000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H" sz="24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*</a:t>
            </a:r>
            <a:endParaRPr lang="en-CH" sz="2400" dirty="0">
              <a:effectLst/>
              <a:latin typeface="Symbol" panose="05050102010706020507" pitchFamily="18" charset="2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B1457F5-CFDB-774C-99BC-07E2BCCCB2E8}"/>
              </a:ext>
            </a:extLst>
          </p:cNvPr>
          <p:cNvSpPr txBox="1"/>
          <p:nvPr/>
        </p:nvSpPr>
        <p:spPr>
          <a:xfrm>
            <a:off x="7145868" y="707201"/>
            <a:ext cx="338554" cy="47000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H" sz="24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*</a:t>
            </a:r>
            <a:endParaRPr lang="en-CH" sz="2400" dirty="0">
              <a:effectLst/>
              <a:latin typeface="Symbol" panose="05050102010706020507" pitchFamily="18" charset="2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199B260-4F51-DF48-9C65-D44F6CF1008E}"/>
              </a:ext>
            </a:extLst>
          </p:cNvPr>
          <p:cNvSpPr txBox="1"/>
          <p:nvPr/>
        </p:nvSpPr>
        <p:spPr>
          <a:xfrm>
            <a:off x="3939450" y="1009558"/>
            <a:ext cx="338554" cy="47000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H" sz="24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*</a:t>
            </a:r>
            <a:endParaRPr lang="en-CH" sz="2400" dirty="0">
              <a:effectLst/>
              <a:latin typeface="Symbol" panose="05050102010706020507" pitchFamily="18" charset="2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169CDF3-BEE7-B947-B89A-19D415D2BA65}"/>
              </a:ext>
            </a:extLst>
          </p:cNvPr>
          <p:cNvSpPr txBox="1"/>
          <p:nvPr/>
        </p:nvSpPr>
        <p:spPr>
          <a:xfrm>
            <a:off x="1899330" y="1008027"/>
            <a:ext cx="338554" cy="47000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CH" sz="24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*</a:t>
            </a:r>
            <a:endParaRPr lang="en-CH" sz="2400" dirty="0">
              <a:effectLst/>
              <a:latin typeface="Symbol" panose="05050102010706020507" pitchFamily="18" charset="2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40432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F90E291-0259-7042-A0F6-14C597C62263}"/>
              </a:ext>
            </a:extLst>
          </p:cNvPr>
          <p:cNvSpPr txBox="1"/>
          <p:nvPr/>
        </p:nvSpPr>
        <p:spPr>
          <a:xfrm>
            <a:off x="457200" y="4343403"/>
            <a:ext cx="112776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CH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upplementary </a:t>
            </a:r>
            <a:r>
              <a:rPr lang="en-GB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: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isin stress growth efficiency comparison between WT and the single (∆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∆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B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∆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double (∆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B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∆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A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∆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A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triple (∆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AB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letion mutants of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monocytogene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GDe and their selected complemented strains. Growth parameters AUC under nisin stress normalized to growth in nisin free BHI were determined for the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sp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s and expressed relative to WT strain levels (WT strain levels equivalent to 1.0 are denoted by a broken line on the graph). Results presented are based on at three independent experiments that were performed in duplicates. *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5 significant differences compared to the WT or complemented strain detected using Tukey post-hoc test pairwise comparison following one-way ANOVA.</a:t>
            </a:r>
            <a:endParaRPr lang="en-CH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BB63C2E-1FB4-7145-B49E-50AE3DA318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28900" y="484809"/>
            <a:ext cx="6934200" cy="355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92630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DFCA5AB-8038-D148-8508-F5D0A50F80CF}"/>
              </a:ext>
            </a:extLst>
          </p:cNvPr>
          <p:cNvSpPr txBox="1"/>
          <p:nvPr/>
        </p:nvSpPr>
        <p:spPr>
          <a:xfrm>
            <a:off x="154983" y="5476918"/>
            <a:ext cx="11705905" cy="120032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Nisin stress growth efficiency comparison between EGDe WT and the single (∆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A::pPL2-csp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double (∆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AB, ∆cspB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triple (∆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AB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letion mutants as well as their respective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 gen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lemented strains. Growth </a:t>
            </a:r>
            <a:r>
              <a:rPr lang="en-GB" sz="12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parameter maximum density (MD) under cold (8</a:t>
            </a:r>
            <a:r>
              <a:rPr lang="en-GB" sz="1200" baseline="300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C) or dual cold and nisin stress </a:t>
            </a:r>
            <a:r>
              <a:rPr lang="en-GB" sz="120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(</a:t>
            </a:r>
            <a:r>
              <a:rPr lang="en-GB" sz="1200" b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N: </a:t>
            </a:r>
            <a:r>
              <a:rPr lang="en-GB" sz="12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5ppm) normalized to normal BHI growth parameters determined for the</a:t>
            </a:r>
            <a:r>
              <a:rPr lang="en-GB" sz="1200" i="1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 csp </a:t>
            </a:r>
            <a:r>
              <a:rPr lang="en-GB" sz="12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mutant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expressed relative to the WT strain levels (WT strain levels equivalent to 1.0 are denoted by a broken line in the graph).</a:t>
            </a:r>
            <a:r>
              <a:rPr lang="en-GB" sz="12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 Results presented are based on three independent experiments that were performed in duplicates. * </a:t>
            </a:r>
            <a:r>
              <a:rPr lang="en-GB" sz="1200" i="1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P</a:t>
            </a:r>
            <a:r>
              <a:rPr lang="en-GB" sz="12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&lt;0.05 significant differences compared to the WT detected using Tukey post-hoc test pairwise comparison following one-way ANOVA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809C000-B5C2-B542-8B9C-A8ABEF3D32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7219" y="596182"/>
            <a:ext cx="7948904" cy="45986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56295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3267A0A-B222-5A43-A568-A9A4F3D0F5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43774" y="863600"/>
            <a:ext cx="2070100" cy="25654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C4F242A-CD90-D54B-B869-679D8B3D69D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79074" y="863600"/>
            <a:ext cx="2095500" cy="25654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7C6E72F-5A7E-D74A-B68B-77DD9EEC7707}"/>
              </a:ext>
            </a:extLst>
          </p:cNvPr>
          <p:cNvSpPr txBox="1"/>
          <p:nvPr/>
        </p:nvSpPr>
        <p:spPr>
          <a:xfrm>
            <a:off x="280417" y="4061837"/>
            <a:ext cx="11436848" cy="83099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Impact of the ∆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AB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tion on mRNA abundance of selected stress response genes. (A) Relative two component system (TCS) genes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sK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sR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aR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levels in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monocytogenes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De_∆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spAB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expressed relative to the WT strain (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T level is 1.0 and is denoted by a dotted line). RT-qPCR was performed on mRNA isolated from exponentially growing cells cultivated in nisin (1.5 ppm) supplemented BHI broth (B) Data on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r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l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in response to nisin stress is presented as scatter plots showing the mean and SD (number of independent biological replicates =3). 16S rRNA was used for normalization. </a:t>
            </a:r>
            <a:r>
              <a:rPr lang="en-GB" sz="12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* </a:t>
            </a:r>
            <a:r>
              <a:rPr lang="en-GB" sz="1200" i="1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P</a:t>
            </a:r>
            <a:r>
              <a:rPr lang="en-GB" sz="12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&lt;0.05 significant differences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022FCFA-1125-F449-9266-BF1D2522FAAE}"/>
              </a:ext>
            </a:extLst>
          </p:cNvPr>
          <p:cNvSpPr txBox="1"/>
          <p:nvPr/>
        </p:nvSpPr>
        <p:spPr>
          <a:xfrm>
            <a:off x="764645" y="667328"/>
            <a:ext cx="357266" cy="381823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GB" b="1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F329B7A-E729-2942-B95B-1BCA197DC342}"/>
              </a:ext>
            </a:extLst>
          </p:cNvPr>
          <p:cNvSpPr txBox="1"/>
          <p:nvPr/>
        </p:nvSpPr>
        <p:spPr>
          <a:xfrm>
            <a:off x="3984921" y="667328"/>
            <a:ext cx="357266" cy="381823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GB" b="1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66B146D-DD49-8B4C-8832-78E05EE8EEA3}"/>
              </a:ext>
            </a:extLst>
          </p:cNvPr>
          <p:cNvSpPr txBox="1"/>
          <p:nvPr/>
        </p:nvSpPr>
        <p:spPr>
          <a:xfrm>
            <a:off x="7205197" y="667328"/>
            <a:ext cx="357266" cy="381823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GB" b="1" dirty="0">
                <a:latin typeface="Palatino Linotype" panose="02040502050505030304" pitchFamily="18" charset="0"/>
              </a:rPr>
              <a:t>C</a:t>
            </a:r>
          </a:p>
        </p:txBody>
      </p:sp>
      <p:pic>
        <p:nvPicPr>
          <p:cNvPr id="4" name="Picture 3" descr="Chart&#10;&#10;Description automatically generated">
            <a:extLst>
              <a:ext uri="{FF2B5EF4-FFF2-40B4-BE49-F238E27FC236}">
                <a16:creationId xmlns:a16="http://schemas.microsoft.com/office/drawing/2014/main" id="{A7D66D20-204C-964A-A30B-792D3E23C3E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2268" y="862900"/>
            <a:ext cx="1931330" cy="256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94509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19279AE7-95EB-FD4F-B652-BD590A985F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1068" y="1185794"/>
            <a:ext cx="2095500" cy="25781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D333D56-C4C9-4048-A4C9-9CBBE46483CD}"/>
              </a:ext>
            </a:extLst>
          </p:cNvPr>
          <p:cNvSpPr txBox="1"/>
          <p:nvPr/>
        </p:nvSpPr>
        <p:spPr>
          <a:xfrm>
            <a:off x="198782" y="4038603"/>
            <a:ext cx="112776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CH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upplementary </a:t>
            </a:r>
            <a:r>
              <a:rPr lang="en-GB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5.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. monocytogenes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CA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amnosyltransferase</a:t>
            </a:r>
            <a:r>
              <a:rPr lang="en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 expression is hindered without Csps</a:t>
            </a:r>
            <a:r>
              <a:rPr lang="en-GB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Presented are bar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aphs showing quantification of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ml</a:t>
            </a:r>
            <a:r>
              <a:rPr lang="en-US" sz="12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mo1085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mRNA levels using RT-qPCR in EGDe WT and ∆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spABD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trains cultivated 4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rs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t 37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 in minimum defined media containing L-rhamnose as the sole C-source. Relative quantities (RQ) of mRNA levels were normalized to 16S rRNA and t</a:t>
            </a:r>
            <a:r>
              <a:rPr lang="en-US" sz="12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RNA levels.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****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tistically significant differences between WT and the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sp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utant (P &lt; 0.0001).</a:t>
            </a:r>
            <a:endParaRPr lang="en-CH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06965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1</TotalTime>
  <Words>644</Words>
  <Application>Microsoft Macintosh PowerPoint</Application>
  <PresentationFormat>Widescreen</PresentationFormat>
  <Paragraphs>1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rial</vt:lpstr>
      <vt:lpstr>Calibri</vt:lpstr>
      <vt:lpstr>Calibri Light</vt:lpstr>
      <vt:lpstr>Palatino Linotype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Francis Muchaamba</cp:lastModifiedBy>
  <cp:revision>1628</cp:revision>
  <dcterms:created xsi:type="dcterms:W3CDTF">2019-11-25T09:17:02Z</dcterms:created>
  <dcterms:modified xsi:type="dcterms:W3CDTF">2021-12-15T19:10:54Z</dcterms:modified>
</cp:coreProperties>
</file>